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Relationship Id="rId6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4"/>
  </p:sldMasterIdLst>
  <p:notesMasterIdLst>
    <p:notesMasterId r:id="rId6"/>
  </p:notesMasterIdLst>
  <p:sldIdLst>
    <p:sldId id="260" r:id="rId5"/>
  </p:sldIdLst>
  <p:sldSz cx="18000663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616EE"/>
    <a:srgbClr val="060173"/>
    <a:srgbClr val="4958E7"/>
    <a:srgbClr val="723F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37" d="100"/>
          <a:sy n="37" d="100"/>
        </p:scale>
        <p:origin x="1080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711BC4-E22B-4E9B-BE78-28979DDC1BE4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223963" y="1143000"/>
            <a:ext cx="4410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B639A5-3C02-4244-BEBB-80D66B1809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6734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1pPr>
    <a:lvl2pPr marL="758815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2pPr>
    <a:lvl3pPr marL="1517632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3pPr>
    <a:lvl4pPr marL="2276448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4pPr>
    <a:lvl5pPr marL="3035265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5pPr>
    <a:lvl6pPr marL="3794080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6pPr>
    <a:lvl7pPr marL="4552896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7pPr>
    <a:lvl8pPr marL="5311713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8pPr>
    <a:lvl9pPr marL="6070528" algn="l" defTabSz="1517632" rtl="0" eaLnBrk="1" latinLnBrk="1" hangingPunct="1">
      <a:defRPr sz="199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062083"/>
            <a:ext cx="15300564" cy="4386662"/>
          </a:xfrm>
        </p:spPr>
        <p:txBody>
          <a:bodyPr anchor="b"/>
          <a:lstStyle>
            <a:lvl1pPr algn="ctr">
              <a:defRPr sz="1102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6617911"/>
            <a:ext cx="13500497" cy="3042080"/>
          </a:xfrm>
        </p:spPr>
        <p:txBody>
          <a:bodyPr/>
          <a:lstStyle>
            <a:lvl1pPr marL="0" indent="0" algn="ctr">
              <a:buNone/>
              <a:defRPr sz="4410"/>
            </a:lvl1pPr>
            <a:lvl2pPr marL="840014" indent="0" algn="ctr">
              <a:buNone/>
              <a:defRPr sz="3675"/>
            </a:lvl2pPr>
            <a:lvl3pPr marL="1680027" indent="0" algn="ctr">
              <a:buNone/>
              <a:defRPr sz="3307"/>
            </a:lvl3pPr>
            <a:lvl4pPr marL="2520041" indent="0" algn="ctr">
              <a:buNone/>
              <a:defRPr sz="2940"/>
            </a:lvl4pPr>
            <a:lvl5pPr marL="3360054" indent="0" algn="ctr">
              <a:buNone/>
              <a:defRPr sz="2940"/>
            </a:lvl5pPr>
            <a:lvl6pPr marL="4200068" indent="0" algn="ctr">
              <a:buNone/>
              <a:defRPr sz="2940"/>
            </a:lvl6pPr>
            <a:lvl7pPr marL="5040081" indent="0" algn="ctr">
              <a:buNone/>
              <a:defRPr sz="2940"/>
            </a:lvl7pPr>
            <a:lvl8pPr marL="5880095" indent="0" algn="ctr">
              <a:buNone/>
              <a:defRPr sz="2940"/>
            </a:lvl8pPr>
            <a:lvl9pPr marL="6720108" indent="0" algn="ctr">
              <a:buNone/>
              <a:defRPr sz="294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019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64080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670833"/>
            <a:ext cx="3881393" cy="1067790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670833"/>
            <a:ext cx="11419171" cy="1067790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9834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5436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141251"/>
            <a:ext cx="15525572" cy="5241244"/>
          </a:xfrm>
        </p:spPr>
        <p:txBody>
          <a:bodyPr anchor="b"/>
          <a:lstStyle>
            <a:lvl1pPr>
              <a:defRPr sz="1102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8432079"/>
            <a:ext cx="15525572" cy="2756246"/>
          </a:xfrm>
        </p:spPr>
        <p:txBody>
          <a:bodyPr/>
          <a:lstStyle>
            <a:lvl1pPr marL="0" indent="0">
              <a:buNone/>
              <a:defRPr sz="4410">
                <a:solidFill>
                  <a:schemeClr val="tx1"/>
                </a:solidFill>
              </a:defRPr>
            </a:lvl1pPr>
            <a:lvl2pPr marL="840014" indent="0">
              <a:buNone/>
              <a:defRPr sz="3675">
                <a:solidFill>
                  <a:schemeClr val="tx1">
                    <a:tint val="75000"/>
                  </a:schemeClr>
                </a:solidFill>
              </a:defRPr>
            </a:lvl2pPr>
            <a:lvl3pPr marL="1680027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3pPr>
            <a:lvl4pPr marL="2520041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4pPr>
            <a:lvl5pPr marL="3360054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5pPr>
            <a:lvl6pPr marL="420006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6pPr>
            <a:lvl7pPr marL="5040081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7pPr>
            <a:lvl8pPr marL="5880095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8pPr>
            <a:lvl9pPr marL="6720108" indent="0">
              <a:buNone/>
              <a:defRPr sz="29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990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354163"/>
            <a:ext cx="7650282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354163"/>
            <a:ext cx="7650282" cy="7994577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0728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670836"/>
            <a:ext cx="15525572" cy="243541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088748"/>
            <a:ext cx="7615123" cy="1513748"/>
          </a:xfrm>
        </p:spPr>
        <p:txBody>
          <a:bodyPr anchor="b"/>
          <a:lstStyle>
            <a:lvl1pPr marL="0" indent="0">
              <a:buNone/>
              <a:defRPr sz="4410" b="1"/>
            </a:lvl1pPr>
            <a:lvl2pPr marL="840014" indent="0">
              <a:buNone/>
              <a:defRPr sz="3675" b="1"/>
            </a:lvl2pPr>
            <a:lvl3pPr marL="1680027" indent="0">
              <a:buNone/>
              <a:defRPr sz="3307" b="1"/>
            </a:lvl3pPr>
            <a:lvl4pPr marL="2520041" indent="0">
              <a:buNone/>
              <a:defRPr sz="2940" b="1"/>
            </a:lvl4pPr>
            <a:lvl5pPr marL="3360054" indent="0">
              <a:buNone/>
              <a:defRPr sz="2940" b="1"/>
            </a:lvl5pPr>
            <a:lvl6pPr marL="4200068" indent="0">
              <a:buNone/>
              <a:defRPr sz="2940" b="1"/>
            </a:lvl6pPr>
            <a:lvl7pPr marL="5040081" indent="0">
              <a:buNone/>
              <a:defRPr sz="2940" b="1"/>
            </a:lvl7pPr>
            <a:lvl8pPr marL="5880095" indent="0">
              <a:buNone/>
              <a:defRPr sz="2940" b="1"/>
            </a:lvl8pPr>
            <a:lvl9pPr marL="6720108" indent="0">
              <a:buNone/>
              <a:defRPr sz="294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4602496"/>
            <a:ext cx="7615123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088748"/>
            <a:ext cx="7652626" cy="1513748"/>
          </a:xfrm>
        </p:spPr>
        <p:txBody>
          <a:bodyPr anchor="b"/>
          <a:lstStyle>
            <a:lvl1pPr marL="0" indent="0">
              <a:buNone/>
              <a:defRPr sz="4410" b="1"/>
            </a:lvl1pPr>
            <a:lvl2pPr marL="840014" indent="0">
              <a:buNone/>
              <a:defRPr sz="3675" b="1"/>
            </a:lvl2pPr>
            <a:lvl3pPr marL="1680027" indent="0">
              <a:buNone/>
              <a:defRPr sz="3307" b="1"/>
            </a:lvl3pPr>
            <a:lvl4pPr marL="2520041" indent="0">
              <a:buNone/>
              <a:defRPr sz="2940" b="1"/>
            </a:lvl4pPr>
            <a:lvl5pPr marL="3360054" indent="0">
              <a:buNone/>
              <a:defRPr sz="2940" b="1"/>
            </a:lvl5pPr>
            <a:lvl6pPr marL="4200068" indent="0">
              <a:buNone/>
              <a:defRPr sz="2940" b="1"/>
            </a:lvl6pPr>
            <a:lvl7pPr marL="5040081" indent="0">
              <a:buNone/>
              <a:defRPr sz="2940" b="1"/>
            </a:lvl7pPr>
            <a:lvl8pPr marL="5880095" indent="0">
              <a:buNone/>
              <a:defRPr sz="2940" b="1"/>
            </a:lvl8pPr>
            <a:lvl9pPr marL="6720108" indent="0">
              <a:buNone/>
              <a:defRPr sz="294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4602496"/>
            <a:ext cx="7652626" cy="676957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0909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4303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2451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39999"/>
            <a:ext cx="5805682" cy="2939997"/>
          </a:xfrm>
        </p:spPr>
        <p:txBody>
          <a:bodyPr anchor="b"/>
          <a:lstStyle>
            <a:lvl1pPr>
              <a:defRPr sz="587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1814168"/>
            <a:ext cx="9112836" cy="8954158"/>
          </a:xfrm>
        </p:spPr>
        <p:txBody>
          <a:bodyPr/>
          <a:lstStyle>
            <a:lvl1pPr>
              <a:defRPr sz="5879"/>
            </a:lvl1pPr>
            <a:lvl2pPr>
              <a:defRPr sz="5144"/>
            </a:lvl2pPr>
            <a:lvl3pPr>
              <a:defRPr sz="4410"/>
            </a:lvl3pPr>
            <a:lvl4pPr>
              <a:defRPr sz="3675"/>
            </a:lvl4pPr>
            <a:lvl5pPr>
              <a:defRPr sz="3675"/>
            </a:lvl5pPr>
            <a:lvl6pPr>
              <a:defRPr sz="3675"/>
            </a:lvl6pPr>
            <a:lvl7pPr>
              <a:defRPr sz="3675"/>
            </a:lvl7pPr>
            <a:lvl8pPr>
              <a:defRPr sz="3675"/>
            </a:lvl8pPr>
            <a:lvl9pPr>
              <a:defRPr sz="3675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3779996"/>
            <a:ext cx="5805682" cy="7002911"/>
          </a:xfrm>
        </p:spPr>
        <p:txBody>
          <a:bodyPr/>
          <a:lstStyle>
            <a:lvl1pPr marL="0" indent="0">
              <a:buNone/>
              <a:defRPr sz="2940"/>
            </a:lvl1pPr>
            <a:lvl2pPr marL="840014" indent="0">
              <a:buNone/>
              <a:defRPr sz="2572"/>
            </a:lvl2pPr>
            <a:lvl3pPr marL="1680027" indent="0">
              <a:buNone/>
              <a:defRPr sz="2205"/>
            </a:lvl3pPr>
            <a:lvl4pPr marL="2520041" indent="0">
              <a:buNone/>
              <a:defRPr sz="1837"/>
            </a:lvl4pPr>
            <a:lvl5pPr marL="3360054" indent="0">
              <a:buNone/>
              <a:defRPr sz="1837"/>
            </a:lvl5pPr>
            <a:lvl6pPr marL="4200068" indent="0">
              <a:buNone/>
              <a:defRPr sz="1837"/>
            </a:lvl6pPr>
            <a:lvl7pPr marL="5040081" indent="0">
              <a:buNone/>
              <a:defRPr sz="1837"/>
            </a:lvl7pPr>
            <a:lvl8pPr marL="5880095" indent="0">
              <a:buNone/>
              <a:defRPr sz="1837"/>
            </a:lvl8pPr>
            <a:lvl9pPr marL="6720108" indent="0">
              <a:buNone/>
              <a:defRPr sz="1837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4559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839999"/>
            <a:ext cx="5805682" cy="2939997"/>
          </a:xfrm>
        </p:spPr>
        <p:txBody>
          <a:bodyPr anchor="b"/>
          <a:lstStyle>
            <a:lvl1pPr>
              <a:defRPr sz="587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1814168"/>
            <a:ext cx="9112836" cy="8954158"/>
          </a:xfrm>
        </p:spPr>
        <p:txBody>
          <a:bodyPr anchor="t"/>
          <a:lstStyle>
            <a:lvl1pPr marL="0" indent="0">
              <a:buNone/>
              <a:defRPr sz="5879"/>
            </a:lvl1pPr>
            <a:lvl2pPr marL="840014" indent="0">
              <a:buNone/>
              <a:defRPr sz="5144"/>
            </a:lvl2pPr>
            <a:lvl3pPr marL="1680027" indent="0">
              <a:buNone/>
              <a:defRPr sz="4410"/>
            </a:lvl3pPr>
            <a:lvl4pPr marL="2520041" indent="0">
              <a:buNone/>
              <a:defRPr sz="3675"/>
            </a:lvl4pPr>
            <a:lvl5pPr marL="3360054" indent="0">
              <a:buNone/>
              <a:defRPr sz="3675"/>
            </a:lvl5pPr>
            <a:lvl6pPr marL="4200068" indent="0">
              <a:buNone/>
              <a:defRPr sz="3675"/>
            </a:lvl6pPr>
            <a:lvl7pPr marL="5040081" indent="0">
              <a:buNone/>
              <a:defRPr sz="3675"/>
            </a:lvl7pPr>
            <a:lvl8pPr marL="5880095" indent="0">
              <a:buNone/>
              <a:defRPr sz="3675"/>
            </a:lvl8pPr>
            <a:lvl9pPr marL="6720108" indent="0">
              <a:buNone/>
              <a:defRPr sz="367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3779996"/>
            <a:ext cx="5805682" cy="7002911"/>
          </a:xfrm>
        </p:spPr>
        <p:txBody>
          <a:bodyPr/>
          <a:lstStyle>
            <a:lvl1pPr marL="0" indent="0">
              <a:buNone/>
              <a:defRPr sz="2940"/>
            </a:lvl1pPr>
            <a:lvl2pPr marL="840014" indent="0">
              <a:buNone/>
              <a:defRPr sz="2572"/>
            </a:lvl2pPr>
            <a:lvl3pPr marL="1680027" indent="0">
              <a:buNone/>
              <a:defRPr sz="2205"/>
            </a:lvl3pPr>
            <a:lvl4pPr marL="2520041" indent="0">
              <a:buNone/>
              <a:defRPr sz="1837"/>
            </a:lvl4pPr>
            <a:lvl5pPr marL="3360054" indent="0">
              <a:buNone/>
              <a:defRPr sz="1837"/>
            </a:lvl5pPr>
            <a:lvl6pPr marL="4200068" indent="0">
              <a:buNone/>
              <a:defRPr sz="1837"/>
            </a:lvl6pPr>
            <a:lvl7pPr marL="5040081" indent="0">
              <a:buNone/>
              <a:defRPr sz="1837"/>
            </a:lvl7pPr>
            <a:lvl8pPr marL="5880095" indent="0">
              <a:buNone/>
              <a:defRPr sz="1837"/>
            </a:lvl8pPr>
            <a:lvl9pPr marL="6720108" indent="0">
              <a:buNone/>
              <a:defRPr sz="1837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6568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670836"/>
            <a:ext cx="15525572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354163"/>
            <a:ext cx="15525572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1678325"/>
            <a:ext cx="405014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97396-9711-435A-9817-BB78D2F7350F}" type="datetimeFigureOut">
              <a:rPr lang="ko-KR" altLang="en-US" smtClean="0"/>
              <a:t>2022-01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1678325"/>
            <a:ext cx="6075224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1678325"/>
            <a:ext cx="405014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2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A0D7A-8A04-47AE-A410-CB5DE76F105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62501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80027" rtl="0" eaLnBrk="1" latinLnBrk="1" hangingPunct="1">
        <a:lnSpc>
          <a:spcPct val="90000"/>
        </a:lnSpc>
        <a:spcBef>
          <a:spcPct val="0"/>
        </a:spcBef>
        <a:buNone/>
        <a:defRPr sz="8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0007" indent="-420007" algn="l" defTabSz="1680027" rtl="0" eaLnBrk="1" latinLnBrk="1" hangingPunct="1">
        <a:lnSpc>
          <a:spcPct val="90000"/>
        </a:lnSpc>
        <a:spcBef>
          <a:spcPts val="1837"/>
        </a:spcBef>
        <a:buFont typeface="Arial" panose="020B0604020202020204" pitchFamily="34" charset="0"/>
        <a:buChar char="•"/>
        <a:defRPr sz="5144" kern="1200">
          <a:solidFill>
            <a:schemeClr val="tx1"/>
          </a:solidFill>
          <a:latin typeface="+mn-lt"/>
          <a:ea typeface="+mn-ea"/>
          <a:cs typeface="+mn-cs"/>
        </a:defRPr>
      </a:lvl1pPr>
      <a:lvl2pPr marL="1260020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4410" kern="1200">
          <a:solidFill>
            <a:schemeClr val="tx1"/>
          </a:solidFill>
          <a:latin typeface="+mn-lt"/>
          <a:ea typeface="+mn-ea"/>
          <a:cs typeface="+mn-cs"/>
        </a:defRPr>
      </a:lvl2pPr>
      <a:lvl3pPr marL="2100034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675" kern="1200">
          <a:solidFill>
            <a:schemeClr val="tx1"/>
          </a:solidFill>
          <a:latin typeface="+mn-lt"/>
          <a:ea typeface="+mn-ea"/>
          <a:cs typeface="+mn-cs"/>
        </a:defRPr>
      </a:lvl3pPr>
      <a:lvl4pPr marL="2940047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4pPr>
      <a:lvl5pPr marL="3780061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5pPr>
      <a:lvl6pPr marL="4620075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6pPr>
      <a:lvl7pPr marL="5460088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7pPr>
      <a:lvl8pPr marL="6300102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8pPr>
      <a:lvl9pPr marL="7140115" indent="-420007" algn="l" defTabSz="1680027" rtl="0" eaLnBrk="1" latinLnBrk="1" hangingPunct="1">
        <a:lnSpc>
          <a:spcPct val="90000"/>
        </a:lnSpc>
        <a:spcBef>
          <a:spcPts val="91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40014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680027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520041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4pPr>
      <a:lvl5pPr marL="3360054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5pPr>
      <a:lvl6pPr marL="4200068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6pPr>
      <a:lvl7pPr marL="5040081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7pPr>
      <a:lvl8pPr marL="5880095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8pPr>
      <a:lvl9pPr marL="6720108" algn="l" defTabSz="1680027" rtl="0" eaLnBrk="1" latinLnBrk="1" hangingPunct="1">
        <a:defRPr sz="330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그룹 26"/>
          <p:cNvGrpSpPr/>
          <p:nvPr/>
        </p:nvGrpSpPr>
        <p:grpSpPr>
          <a:xfrm>
            <a:off x="2585546" y="772510"/>
            <a:ext cx="13038081" cy="9616965"/>
            <a:chOff x="3232778" y="1270000"/>
            <a:chExt cx="5839496" cy="4318000"/>
          </a:xfrm>
        </p:grpSpPr>
        <p:pic>
          <p:nvPicPr>
            <p:cNvPr id="23" name="Imagen 14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969"/>
            <a:stretch/>
          </p:blipFill>
          <p:spPr bwMode="auto">
            <a:xfrm>
              <a:off x="3261042" y="1270000"/>
              <a:ext cx="5669915" cy="431800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24" name="모서리가 둥근 직사각형 23"/>
            <p:cNvSpPr/>
            <p:nvPr/>
          </p:nvSpPr>
          <p:spPr>
            <a:xfrm>
              <a:off x="3232778" y="3908437"/>
              <a:ext cx="5839496" cy="81672"/>
            </a:xfrm>
            <a:prstGeom prst="roundRect">
              <a:avLst/>
            </a:prstGeom>
            <a:noFill/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1453276">
                <a:defRPr/>
              </a:pPr>
              <a:endParaRPr lang="ko-KR" altLang="en-US" sz="2862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25" name="모서리가 둥근 직사각형 24"/>
            <p:cNvSpPr/>
            <p:nvPr/>
          </p:nvSpPr>
          <p:spPr>
            <a:xfrm rot="16200000">
              <a:off x="3995316" y="3813688"/>
              <a:ext cx="3208713" cy="103460"/>
            </a:xfrm>
            <a:prstGeom prst="roundRect">
              <a:avLst/>
            </a:prstGeom>
            <a:noFill/>
            <a:ln w="3175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 defTabSz="1453276">
                <a:defRPr/>
              </a:pPr>
              <a:endParaRPr lang="ko-KR" altLang="en-US" sz="2862">
                <a:solidFill>
                  <a:prstClr val="white"/>
                </a:solidFill>
                <a:latin typeface="맑은 고딕" panose="020F0502020204030204"/>
                <a:ea typeface="맑은 고딕" panose="020B0503020000020004" pitchFamily="50" charset="-127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2195998" y="10696363"/>
            <a:ext cx="1504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I matrix of 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ithiobacillus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es,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thiobaillus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pidarius</a:t>
            </a:r>
            <a:r>
              <a:rPr lang="en-US" altLang="ko-KR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ig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. Contig 1 represents the new species AZ11. The numbers represent the % of average nucleotide identity; the red-colored areas indicate closely related microorganisms that could be considered the same species.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0232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EditorName xmlns="http://schemas.microsoft.com/sharepoint/v3" xsi:nil="true"/>
    <DocSecurityLevel xmlns="http://schemas.microsoft.com/sharepoint/v3" xsi:nil="true"/>
    <AuthorName xmlns="http://schemas.microsoft.com/sharepoint/v3" xsi:nil="true"/>
    <DocSharedFile xmlns="http://schemas.microsoft.com/sharepoint/v3" xsi:nil="true"/>
    <AuthorDept xmlns="http://schemas.microsoft.com/sharepoint/v3" xsi:nil="true"/>
    <EditorDept xmlns="http://schemas.microsoft.com/sharepoint/v3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SKDocLibContentType" ma:contentTypeID="0x010100F232DC283A0D4D749B6A46903F588C0D009E72DB2D3FF3374ABE5B05052C21B7CF" ma:contentTypeVersion="0" ma:contentTypeDescription="ECM 커스텀 문서라이브러리 컨텐츠 타입" ma:contentTypeScope="" ma:versionID="0478e52725bd7ad217fb754f0279a861">
  <xsd:schema xmlns:xsd="http://www.w3.org/2001/XMLSchema" xmlns:xs="http://www.w3.org/2001/XMLSchema" xmlns:p="http://schemas.microsoft.com/office/2006/metadata/properties" xmlns:ns1="http://schemas.microsoft.com/sharepoint/v3" targetNamespace="http://schemas.microsoft.com/office/2006/metadata/properties" ma:root="true" ma:fieldsID="264f86e185e95eddd4a136428f9a436a" ns1:_="">
    <xsd:import namespace="http://schemas.microsoft.com/sharepoint/v3"/>
    <xsd:element name="properties">
      <xsd:complexType>
        <xsd:sequence>
          <xsd:element name="documentManagement">
            <xsd:complexType>
              <xsd:all>
                <xsd:element ref="ns1:AuthorName" minOccurs="0"/>
                <xsd:element ref="ns1:AuthorDept" minOccurs="0"/>
                <xsd:element ref="ns1:EditorName" minOccurs="0"/>
                <xsd:element ref="ns1:EditorDept" minOccurs="0"/>
                <xsd:element ref="ns1:DocSecurityLevel" minOccurs="0"/>
                <xsd:element ref="ns1:DocSharedFil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AuthorName" ma:index="7" nillable="true" ma:displayName="작성자" ma:description="작성자 이름 필드" ma:internalName="AuthorName">
      <xsd:simpleType>
        <xsd:restriction base="dms:Text"/>
      </xsd:simpleType>
    </xsd:element>
    <xsd:element name="AuthorDept" ma:index="8" nillable="true" ma:displayName="작성자 부서" ma:description="작성자 부서 필드" ma:internalName="AuthorDept">
      <xsd:simpleType>
        <xsd:restriction base="dms:Text"/>
      </xsd:simpleType>
    </xsd:element>
    <xsd:element name="EditorName" ma:index="9" nillable="true" ma:displayName="수정자" ma:description="수정자 이름 필드" ma:hidden="true" ma:internalName="EditorName">
      <xsd:simpleType>
        <xsd:restriction base="dms:Text"/>
      </xsd:simpleType>
    </xsd:element>
    <xsd:element name="EditorDept" ma:index="10" nillable="true" ma:displayName="수정자 부서" ma:description="수정자 부서 필드" ma:internalName="EditorDept">
      <xsd:simpleType>
        <xsd:restriction base="dms:Text"/>
      </xsd:simpleType>
    </xsd:element>
    <xsd:element name="DocSecurityLevel" ma:index="11" nillable="true" ma:displayName="보안등급" ma:description="보안등급 필드(문서함)" ma:internalName="DocSecurityLevel">
      <xsd:simpleType>
        <xsd:restriction base="dms:Unknown"/>
      </xsd:simpleType>
    </xsd:element>
    <xsd:element name="DocSharedFile" ma:index="12" nillable="true" ma:displayName="공유" ma:description="파일 공유 여부 필드" ma:internalName="DocSharedFil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/>
        <xsd:element ref="dc:title" minOccurs="0" maxOccurs="1" ma:index="3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5EC7744-6D6D-4E15-BE2B-79F925E02073}"/>
</file>

<file path=customXml/itemProps2.xml><?xml version="1.0" encoding="utf-8"?>
<ds:datastoreItem xmlns:ds="http://schemas.openxmlformats.org/officeDocument/2006/customXml" ds:itemID="{DAB76AC1-73D7-437D-92DA-4E1606444058}"/>
</file>

<file path=customXml/itemProps3.xml><?xml version="1.0" encoding="utf-8"?>
<ds:datastoreItem xmlns:ds="http://schemas.openxmlformats.org/officeDocument/2006/customXml" ds:itemID="{84252ED2-24BF-49E0-8F8A-A363A10170EB}"/>
</file>

<file path=docMetadata/LabelInfo.xml><?xml version="1.0" encoding="utf-8"?>
<clbl:labelList xmlns:clbl="http://schemas.microsoft.com/office/2020/mipLabelMetadata">
  <clbl:label id="{2c1357aa-0960-4b6d-b918-e2668fbe3cee}" enabled="1" method="Privileged" siteId="{a291953b-a95f-4c1e-8127-00ffdb5b7f6c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Words>49</Words>
  <TotalTime>0</TotalTime>
  <Application>Microsoft Office PowerPoint</Application>
  <Template>Office Theme</Template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terms:modified xsi:type="dcterms:W3CDTF">2022-01-07T08:12:58Z</dcterms:modified>
  <dc:title/>
  <cp:lastModifiedBy>Administrator</cp:lastModifiedBy>
  <dcterms:created xsi:type="dcterms:W3CDTF">2021-06-23T08:24:11Z</dcterms:created>
  <cp:revision>94</cp:revision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232DC283A0D4D749B6A46903F588C0D009E72DB2D3FF3374ABE5B05052C21B7CF</vt:lpwstr>
  </property>
</Properties>
</file>